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A67049E6-D56D-4721-B9F2-0E28A70EBB89}"/>
    <pc:docChg chg="modSld">
      <pc:chgData name="Enrique María Mateu de Antonio" userId="678ddb83-0020-4a06-85d2-928a222534ef" providerId="ADAL" clId="{A67049E6-D56D-4721-B9F2-0E28A70EBB89}" dt="2025-04-22T12:47:14.528" v="1" actId="2711"/>
      <pc:docMkLst>
        <pc:docMk/>
      </pc:docMkLst>
      <pc:sldChg chg="modSp mod">
        <pc:chgData name="Enrique María Mateu de Antonio" userId="678ddb83-0020-4a06-85d2-928a222534ef" providerId="ADAL" clId="{A67049E6-D56D-4721-B9F2-0E28A70EBB89}" dt="2025-04-22T12:47:14.528" v="1" actId="2711"/>
        <pc:sldMkLst>
          <pc:docMk/>
          <pc:sldMk cId="3932742058" sldId="256"/>
        </pc:sldMkLst>
        <pc:spChg chg="mod">
          <ac:chgData name="Enrique María Mateu de Antonio" userId="678ddb83-0020-4a06-85d2-928a222534ef" providerId="ADAL" clId="{A67049E6-D56D-4721-B9F2-0E28A70EBB89}" dt="2025-04-22T12:47:14.528" v="1" actId="2711"/>
          <ac:spMkLst>
            <pc:docMk/>
            <pc:sldMk cId="3932742058" sldId="256"/>
            <ac:spMk id="3" creationId="{D1DA7744-F3C4-C4EB-383B-BA55CF9F8015}"/>
          </ac:spMkLst>
        </pc:spChg>
      </pc:sldChg>
    </pc:docChg>
  </pc:docChgLst>
  <pc:docChgLst>
    <pc:chgData name="Enrique María Mateu de Antonio" userId="678ddb83-0020-4a06-85d2-928a222534ef" providerId="ADAL" clId="{F77E932A-4622-4218-99D9-08763F31B7E8}"/>
    <pc:docChg chg="modSld">
      <pc:chgData name="Enrique María Mateu de Antonio" userId="678ddb83-0020-4a06-85d2-928a222534ef" providerId="ADAL" clId="{F77E932A-4622-4218-99D9-08763F31B7E8}" dt="2025-04-07T13:45:23.948" v="7" actId="1076"/>
      <pc:docMkLst>
        <pc:docMk/>
      </pc:docMkLst>
      <pc:sldChg chg="addSp modSp mod">
        <pc:chgData name="Enrique María Mateu de Antonio" userId="678ddb83-0020-4a06-85d2-928a222534ef" providerId="ADAL" clId="{F77E932A-4622-4218-99D9-08763F31B7E8}" dt="2025-04-07T13:45:23.948" v="7" actId="1076"/>
        <pc:sldMkLst>
          <pc:docMk/>
          <pc:sldMk cId="3932742058" sldId="256"/>
        </pc:sldMkLst>
        <pc:spChg chg="add mod">
          <ac:chgData name="Enrique María Mateu de Antonio" userId="678ddb83-0020-4a06-85d2-928a222534ef" providerId="ADAL" clId="{F77E932A-4622-4218-99D9-08763F31B7E8}" dt="2025-04-07T13:45:22.346" v="6" actId="1076"/>
          <ac:spMkLst>
            <pc:docMk/>
            <pc:sldMk cId="3932742058" sldId="256"/>
            <ac:spMk id="3" creationId="{D1DA7744-F3C4-C4EB-383B-BA55CF9F8015}"/>
          </ac:spMkLst>
        </pc:spChg>
        <pc:graphicFrameChg chg="mod">
          <ac:chgData name="Enrique María Mateu de Antonio" userId="678ddb83-0020-4a06-85d2-928a222534ef" providerId="ADAL" clId="{F77E932A-4622-4218-99D9-08763F31B7E8}" dt="2025-04-07T13:45:23.948" v="7" actId="1076"/>
          <ac:graphicFrameMkLst>
            <pc:docMk/>
            <pc:sldMk cId="3932742058" sldId="256"/>
            <ac:graphicFrameMk id="4" creationId="{6A9D1B49-D0C9-69E4-0094-0A7C32F5A4C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F957D95-A691-9857-201C-678BF428F3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FC21A992-AC90-2135-97DB-D58251D914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9B89F10B-8980-D6F8-933B-6C59F05EB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B2240B5C-8A4E-28F3-BF14-E11B7BC05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013B04C6-9450-85AF-F105-E31E028A4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8997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EDFC9F43-2853-05E3-F3A2-88B230EC1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FC614B32-1EE2-F3EF-3E05-CD72B2112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08267EC-A0AB-3180-7ECE-AEA3ED817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D1C04350-BFE1-7197-C21F-E47239E08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22AE0419-D27C-E26F-2175-C8A742F97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5043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38D6D191-A2A2-4B3B-A43E-51F3FC6D44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A6BE9AC9-3ADE-2591-45EB-39AAE0687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45233B1-0AEE-E129-3496-027E74B73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8CA14A44-7BB9-BC84-4E1E-F216C3E9A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31007377-2805-3BA9-738A-4FFAD2D77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4375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FA056C0E-3391-50EA-91A6-5F87B0385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4966CB8D-F19F-690B-922D-5A35741834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C49B7108-F4D9-9923-BC19-8B5642926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3C7BE747-9B0D-77F3-2C64-A754324A4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08438A65-0870-1BBB-D952-A29B921E8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694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C2214BAC-05FB-EC7E-C039-5C60FE759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CD5C2659-58F5-70B6-7CB4-173915D8CF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7DAEA40C-F246-41A8-0813-131453B94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ABA078DD-6749-9B38-500E-684AF6D4A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60BFE01-287C-5AB2-313F-88B48BEC0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2438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E8F9CD5-1272-690D-4BD1-1C7625CF93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93F8B423-B4B7-4EF6-2782-D2B4E26855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57FA2005-B885-B9F5-AA6E-6C8CEBE016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1BEB3A12-BF6B-3331-81E1-B30553DEE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14FEA535-706F-D641-B761-360D2E027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46EE4381-EA76-F906-DCC3-FD42FB511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6428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EA98F3C9-3643-429A-DB6A-538C3EE55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4372B31A-21A6-174F-7BF5-283F20578E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9974E789-6241-3548-735D-8222E385EA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9A13E4B0-1627-8478-D499-2D004D21FC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049AAF5F-DDEA-E0C1-9502-82EE6C8F6F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888D1790-34C4-BEA9-5070-CC8A0EFAC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AF9805F9-03BA-B28D-A2FF-6DD2BFDEA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3EBF2B0E-E452-266C-D521-EB411A13E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406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0B78134-9368-E1A0-FA6F-924AB1005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34FFD461-119E-4B17-34AC-BA579DD1F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649C71CF-140C-764F-DFE3-E72F735F2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887DA812-526B-38A5-BA8A-00882C2B5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7900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6110B84F-8FB2-7C91-6999-7458B6364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8724DCDA-7185-C2B0-064A-6D8DEF3EB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B3ADDCD0-C377-811E-1AFD-CC7D4EEF0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7888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D2AA5D6E-DC91-CE5A-AE56-064E59C4C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B6D92A8F-1EB4-1E63-C9E5-09577DD92A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22FA0EDD-7E98-24B7-F32A-103C50AA67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499589E2-60FA-6537-EFF5-4BA6FA2B5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226332E6-B2C9-F46B-56FD-22CB9D7D8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82610ED9-6D5E-D10D-FEBB-466FA340F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663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AD3C63C-0396-5DAE-DDD2-D23BF613D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7AC9145D-4263-29CF-C72A-7D9D5B3327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15BFFC9F-B1AA-8FEA-7B70-E036070C9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10979B92-E266-A675-B44F-E728DFB02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72496626-ECA3-78E4-EF84-ADEE7E22D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C5037407-E93E-11C8-9C55-53511D679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7270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5B190204-447E-9CD2-EBC4-084FBA0B1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B09A8F62-7904-B97F-4FDE-5A54789AF8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2CC376F-E5F5-CD8A-6EFF-FD897F7D7A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7E4076-E3A8-4A8A-9D6D-20A12B70FDAD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09897F7A-DE38-BF6A-08DE-93626D5313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E7D1F330-D9DB-3729-578E-BF177DF47C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2A806D-5CAD-4C68-AF15-E86A0846DD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2881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e 3">
            <a:extLst>
              <a:ext uri="{FF2B5EF4-FFF2-40B4-BE49-F238E27FC236}">
                <a16:creationId xmlns:a16="http://schemas.microsoft.com/office/drawing/2014/main" id="{6A9D1B49-D0C9-69E4-0094-0A7C32F5A4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001295"/>
              </p:ext>
            </p:extLst>
          </p:nvPr>
        </p:nvGraphicFramePr>
        <p:xfrm>
          <a:off x="3186112" y="1062038"/>
          <a:ext cx="5819775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673052" imgH="7144376" progId="Prism10.Document">
                  <p:embed/>
                </p:oleObj>
              </mc:Choice>
              <mc:Fallback>
                <p:oleObj name="Prism 10" r:id="rId2" imgW="7673052" imgH="7144376" progId="Prism10.Document">
                  <p:embed/>
                  <p:pic>
                    <p:nvPicPr>
                      <p:cNvPr id="4" name="Objecte 3">
                        <a:extLst>
                          <a:ext uri="{FF2B5EF4-FFF2-40B4-BE49-F238E27FC236}">
                            <a16:creationId xmlns:a16="http://schemas.microsoft.com/office/drawing/2014/main" id="{6A9D1B49-D0C9-69E4-0094-0A7C32F5A4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86112" y="1062038"/>
                        <a:ext cx="5819775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QuadreDeText 2">
            <a:extLst>
              <a:ext uri="{FF2B5EF4-FFF2-40B4-BE49-F238E27FC236}">
                <a16:creationId xmlns:a16="http://schemas.microsoft.com/office/drawing/2014/main" id="{D1DA7744-F3C4-C4EB-383B-BA55CF9F8015}"/>
              </a:ext>
            </a:extLst>
          </p:cNvPr>
          <p:cNvSpPr txBox="1"/>
          <p:nvPr/>
        </p:nvSpPr>
        <p:spPr>
          <a:xfrm>
            <a:off x="581025" y="180975"/>
            <a:ext cx="115062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5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stitia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eumonia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urativ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onchopneumonia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s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10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28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t-challe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PC).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= p&lt;0.05; ** = p&lt;0.01; *** = p&lt;0.001, **** =p&lt;0.0001.</a:t>
            </a:r>
          </a:p>
        </p:txBody>
      </p:sp>
    </p:spTree>
    <p:extLst>
      <p:ext uri="{BB962C8B-B14F-4D97-AF65-F5344CB8AC3E}">
        <p14:creationId xmlns:p14="http://schemas.microsoft.com/office/powerpoint/2010/main" val="39327420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81</Words>
  <Application>Microsoft Office PowerPoint</Application>
  <PresentationFormat>Pantalla panoràmica</PresentationFormat>
  <Paragraphs>1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19T11:52:32Z</dcterms:created>
  <dcterms:modified xsi:type="dcterms:W3CDTF">2025-04-22T12:47:16Z</dcterms:modified>
</cp:coreProperties>
</file>